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1"/>
    <p:restoredTop sz="94679"/>
  </p:normalViewPr>
  <p:slideViewPr>
    <p:cSldViewPr snapToGrid="0" snapToObjects="1">
      <p:cViewPr>
        <p:scale>
          <a:sx n="192" d="100"/>
          <a:sy n="192" d="100"/>
        </p:scale>
        <p:origin x="-1744" y="-48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6A6EF-ECBD-D446-9B19-F5833923D8E7}" type="datetimeFigureOut">
              <a:rPr lang="en-US" smtClean="0"/>
              <a:t>1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30272-32E8-6A45-A161-9DE0A712D2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11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3699990"/>
              </p:ext>
            </p:extLst>
          </p:nvPr>
        </p:nvGraphicFramePr>
        <p:xfrm>
          <a:off x="695740" y="2127814"/>
          <a:ext cx="5506277" cy="699281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409607"/>
                <a:gridCol w="1277456"/>
                <a:gridCol w="969106"/>
                <a:gridCol w="925054"/>
                <a:gridCol w="925054"/>
              </a:tblGrid>
              <a:tr h="33049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Locu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Known Phenotype Association</a:t>
                      </a:r>
                      <a:r>
                        <a:rPr lang="en-US" sz="1100" b="1" u="none" strike="noStrike" baseline="30000">
                          <a:effectLst/>
                        </a:rPr>
                        <a:t>1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 smtClean="0">
                          <a:effectLst/>
                        </a:rPr>
                        <a:t>Phy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Locus-based GWA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Variant-based GWA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argJ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2+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ro-RO" sz="1100" b="1" u="none" strike="noStrike" dirty="0">
                          <a:effectLst/>
                        </a:rPr>
                        <a:t>cut5b-Rv3725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eis-Rv2417c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embB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EM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embC-embA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EM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espE-espF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fabG1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N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fadB4-Rv3142c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folC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gid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4, 2+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gyrA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F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gyrB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F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hadA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338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inhA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INH, E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katG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IN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lipJ-cinA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moeX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oxyR'-ahpC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IN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pip-Rv0841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ncA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Z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ncA-Rv2044c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Z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recF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poB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M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poC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M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psL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rs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STM, 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Rv0197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Rv0526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Rv1313c-Rv1314c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3380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Rv1482c-fabG1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INH, E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Rv2668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>
                          <a:effectLst/>
                        </a:rPr>
                        <a:t>Rv3007c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nl-NL" sz="1100" b="1" u="none" strike="noStrike">
                          <a:effectLst/>
                        </a:rPr>
                        <a:t>Rv3115-moeB2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>
                          <a:effectLst/>
                        </a:rPr>
                        <a:t>Rv3128c-Rv3129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thyX-hsdS.1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, 4, 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115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u="none" strike="noStrike" dirty="0" err="1">
                          <a:effectLst/>
                        </a:rPr>
                        <a:t>tuf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Nov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  <a:tr h="3691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whiB6-Rv3863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Putative STM or E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2+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846" marR="6846" marT="6846" marB="0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47863" y="930079"/>
            <a:ext cx="560202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Locus Comparison Table showing which analyses and in which lineage each loci was identified. A ‘x’ indicates a locus which was not identified by the method of analysis in question. Loci without a known association with the phenotype are highlighted in bold. There </a:t>
            </a:r>
            <a:r>
              <a:rPr lang="en-US" sz="1200" dirty="0"/>
              <a:t>were </a:t>
            </a:r>
            <a:r>
              <a:rPr lang="en-US" sz="1200" dirty="0" smtClean="0"/>
              <a:t>9 </a:t>
            </a:r>
            <a:r>
              <a:rPr lang="en-US" sz="1200" dirty="0"/>
              <a:t>loci identified by </a:t>
            </a:r>
            <a:r>
              <a:rPr lang="en-US" sz="1200" dirty="0" err="1"/>
              <a:t>C</a:t>
            </a:r>
            <a:r>
              <a:rPr lang="en-US" sz="1200" dirty="0" err="1" smtClean="0"/>
              <a:t>oll</a:t>
            </a:r>
            <a:r>
              <a:rPr lang="en-US" sz="1200" dirty="0" smtClean="0"/>
              <a:t> et al. (2018) using </a:t>
            </a:r>
            <a:r>
              <a:rPr lang="en-US" sz="1200" dirty="0"/>
              <a:t>the wider non-lineage specific dataset </a:t>
            </a:r>
            <a:r>
              <a:rPr lang="en-US" sz="1200" dirty="0" smtClean="0"/>
              <a:t>that </a:t>
            </a:r>
            <a:r>
              <a:rPr lang="en-US" sz="1200" dirty="0"/>
              <a:t>were not identified </a:t>
            </a:r>
            <a:r>
              <a:rPr lang="en-US" sz="1200" dirty="0" smtClean="0"/>
              <a:t>here</a:t>
            </a:r>
            <a:r>
              <a:rPr lang="en-US" sz="1200" baseline="30000" dirty="0" smtClean="0"/>
              <a:t>13</a:t>
            </a:r>
            <a:r>
              <a:rPr lang="en-US" sz="1200" dirty="0" smtClean="0"/>
              <a:t>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02949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</TotalTime>
  <Words>382</Words>
  <Application>Microsoft Macintosh PowerPoint</Application>
  <PresentationFormat>A4 Paper (210x297 mm)</PresentationFormat>
  <Paragraphs>1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6</cp:revision>
  <dcterms:created xsi:type="dcterms:W3CDTF">2018-02-27T17:26:00Z</dcterms:created>
  <dcterms:modified xsi:type="dcterms:W3CDTF">2019-01-15T15:50:40Z</dcterms:modified>
</cp:coreProperties>
</file>